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96" r:id="rId2"/>
    <p:sldId id="297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2" autoAdjust="0"/>
    <p:restoredTop sz="65259" autoAdjust="0"/>
  </p:normalViewPr>
  <p:slideViewPr>
    <p:cSldViewPr>
      <p:cViewPr>
        <p:scale>
          <a:sx n="150" d="100"/>
          <a:sy n="150" d="100"/>
        </p:scale>
        <p:origin x="-984" y="492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_Diamon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_Diamon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_Diamon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_Diamond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_Diamond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6_Fig.S2_Raw%20data_Diamon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HCC827'!$A$7</c:f>
              <c:strCache>
                <c:ptCount val="1"/>
                <c:pt idx="0">
                  <c:v>XAV939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CC827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CC827'!$B$7:$AE$7</c:f>
              <c:numCache>
                <c:formatCode>General</c:formatCode>
                <c:ptCount val="30"/>
                <c:pt idx="1">
                  <c:v>0.99804526753893497</c:v>
                </c:pt>
                <c:pt idx="4">
                  <c:v>0.99586030074272491</c:v>
                </c:pt>
                <c:pt idx="7">
                  <c:v>0.98092276583941918</c:v>
                </c:pt>
                <c:pt idx="10">
                  <c:v>1.0046781312140702</c:v>
                </c:pt>
                <c:pt idx="13">
                  <c:v>1.0276077284555774</c:v>
                </c:pt>
                <c:pt idx="16">
                  <c:v>0.98269037103107493</c:v>
                </c:pt>
                <c:pt idx="19">
                  <c:v>0.98562559640657288</c:v>
                </c:pt>
                <c:pt idx="22">
                  <c:v>1.0028008378765783</c:v>
                </c:pt>
                <c:pt idx="25">
                  <c:v>0.97155879371558895</c:v>
                </c:pt>
                <c:pt idx="28">
                  <c:v>0.9261684105814664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HCC827'!$A$8</c:f>
              <c:strCache>
                <c:ptCount val="1"/>
                <c:pt idx="0">
                  <c:v>XAV939 Average 2 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CC827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CC827'!$B$8:$AE$8</c:f>
              <c:numCache>
                <c:formatCode>General</c:formatCode>
                <c:ptCount val="30"/>
                <c:pt idx="1">
                  <c:v>0.99933197925912842</c:v>
                </c:pt>
                <c:pt idx="4">
                  <c:v>0.97269803437149038</c:v>
                </c:pt>
                <c:pt idx="7">
                  <c:v>1.0085221272536313</c:v>
                </c:pt>
                <c:pt idx="10">
                  <c:v>0.96514006371414396</c:v>
                </c:pt>
                <c:pt idx="13">
                  <c:v>0.99287293984616565</c:v>
                </c:pt>
                <c:pt idx="16">
                  <c:v>0.99975243312696771</c:v>
                </c:pt>
                <c:pt idx="19">
                  <c:v>0.99133784534971481</c:v>
                </c:pt>
                <c:pt idx="22">
                  <c:v>0.94376770290772494</c:v>
                </c:pt>
                <c:pt idx="25">
                  <c:v>0.95392727631370389</c:v>
                </c:pt>
                <c:pt idx="28">
                  <c:v>0.9103725238825665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HCC827'!$A$9</c:f>
              <c:strCache>
                <c:ptCount val="1"/>
                <c:pt idx="0">
                  <c:v>XAV939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HCC827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CC827'!$B$9:$AE$9</c:f>
              <c:numCache>
                <c:formatCode>General</c:formatCode>
                <c:ptCount val="30"/>
                <c:pt idx="0">
                  <c:v>0.99868862339903175</c:v>
                </c:pt>
                <c:pt idx="1">
                  <c:v>0.99868862339903175</c:v>
                </c:pt>
                <c:pt idx="2">
                  <c:v>0.99868862339903175</c:v>
                </c:pt>
                <c:pt idx="3">
                  <c:v>0.98427916755710765</c:v>
                </c:pt>
                <c:pt idx="4">
                  <c:v>0.98427916755710765</c:v>
                </c:pt>
                <c:pt idx="5">
                  <c:v>0.98427916755710765</c:v>
                </c:pt>
                <c:pt idx="6">
                  <c:v>0.9947224465465252</c:v>
                </c:pt>
                <c:pt idx="7">
                  <c:v>0.9947224465465252</c:v>
                </c:pt>
                <c:pt idx="8">
                  <c:v>0.9947224465465252</c:v>
                </c:pt>
                <c:pt idx="9">
                  <c:v>0.98490909746410704</c:v>
                </c:pt>
                <c:pt idx="10">
                  <c:v>0.98490909746410704</c:v>
                </c:pt>
                <c:pt idx="11">
                  <c:v>0.98490909746410704</c:v>
                </c:pt>
                <c:pt idx="12">
                  <c:v>1.0102403341508714</c:v>
                </c:pt>
                <c:pt idx="13">
                  <c:v>1.0102403341508714</c:v>
                </c:pt>
                <c:pt idx="14">
                  <c:v>1.0102403341508714</c:v>
                </c:pt>
                <c:pt idx="15">
                  <c:v>0.99122140207902132</c:v>
                </c:pt>
                <c:pt idx="16">
                  <c:v>0.99122140207902132</c:v>
                </c:pt>
                <c:pt idx="17">
                  <c:v>0.99122140207902132</c:v>
                </c:pt>
                <c:pt idx="18">
                  <c:v>0.98848172087814379</c:v>
                </c:pt>
                <c:pt idx="19">
                  <c:v>0.98848172087814379</c:v>
                </c:pt>
                <c:pt idx="20">
                  <c:v>0.98848172087814379</c:v>
                </c:pt>
                <c:pt idx="21">
                  <c:v>0.9732842703921516</c:v>
                </c:pt>
                <c:pt idx="22">
                  <c:v>0.9732842703921516</c:v>
                </c:pt>
                <c:pt idx="23">
                  <c:v>0.9732842703921516</c:v>
                </c:pt>
                <c:pt idx="24">
                  <c:v>0.96274303501464642</c:v>
                </c:pt>
                <c:pt idx="25">
                  <c:v>0.96274303501464642</c:v>
                </c:pt>
                <c:pt idx="26">
                  <c:v>0.96274303501464642</c:v>
                </c:pt>
                <c:pt idx="27">
                  <c:v>0.91827046723201655</c:v>
                </c:pt>
                <c:pt idx="28">
                  <c:v>0.91827046723201655</c:v>
                </c:pt>
                <c:pt idx="29">
                  <c:v>0.918270467232016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171520"/>
        <c:axId val="83206144"/>
      </c:scatterChart>
      <c:valAx>
        <c:axId val="83171520"/>
        <c:scaling>
          <c:orientation val="minMax"/>
          <c:max val="11"/>
        </c:scaling>
        <c:delete val="0"/>
        <c:axPos val="b"/>
        <c:numFmt formatCode="General" sourceLinked="1"/>
        <c:majorTickMark val="out"/>
        <c:minorTickMark val="none"/>
        <c:tickLblPos val="none"/>
        <c:crossAx val="83206144"/>
        <c:crosses val="autoZero"/>
        <c:crossBetween val="midCat"/>
        <c:majorUnit val="1"/>
      </c:valAx>
      <c:valAx>
        <c:axId val="8320614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8317152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HCC827'!$A$10</c:f>
              <c:strCache>
                <c:ptCount val="1"/>
                <c:pt idx="0">
                  <c:v>JNJ-BJ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CC827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CC827'!$B$10:$AE$10</c:f>
              <c:numCache>
                <c:formatCode>General</c:formatCode>
                <c:ptCount val="30"/>
                <c:pt idx="1">
                  <c:v>0.98868786296315969</c:v>
                </c:pt>
                <c:pt idx="4">
                  <c:v>0.99498929552952964</c:v>
                </c:pt>
                <c:pt idx="7">
                  <c:v>1.0031588186014739</c:v>
                </c:pt>
                <c:pt idx="10">
                  <c:v>0.98565462599958342</c:v>
                </c:pt>
                <c:pt idx="13">
                  <c:v>0.9866949615118964</c:v>
                </c:pt>
                <c:pt idx="16">
                  <c:v>1.0010600045119173</c:v>
                </c:pt>
                <c:pt idx="19">
                  <c:v>0.98303462784522788</c:v>
                </c:pt>
                <c:pt idx="22">
                  <c:v>1.0007121403549937</c:v>
                </c:pt>
                <c:pt idx="25">
                  <c:v>1.0081083322856439</c:v>
                </c:pt>
                <c:pt idx="28">
                  <c:v>0.9675937370544673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HCC827'!$A$11</c:f>
              <c:strCache>
                <c:ptCount val="1"/>
                <c:pt idx="0">
                  <c:v>JNJ-BJ Average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CC827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CC827'!$B$11:$AE$11</c:f>
              <c:numCache>
                <c:formatCode>General</c:formatCode>
                <c:ptCount val="30"/>
                <c:pt idx="1">
                  <c:v>0.95928270218402345</c:v>
                </c:pt>
                <c:pt idx="4">
                  <c:v>0.97331838173157437</c:v>
                </c:pt>
                <c:pt idx="7">
                  <c:v>0.93007817096511525</c:v>
                </c:pt>
                <c:pt idx="10">
                  <c:v>0.94548777334342049</c:v>
                </c:pt>
                <c:pt idx="13">
                  <c:v>0.94280979045251623</c:v>
                </c:pt>
                <c:pt idx="16">
                  <c:v>0.98019433675316292</c:v>
                </c:pt>
                <c:pt idx="19">
                  <c:v>0.9602122472953204</c:v>
                </c:pt>
                <c:pt idx="22">
                  <c:v>0.95997092724874478</c:v>
                </c:pt>
                <c:pt idx="25">
                  <c:v>0.97179974398304769</c:v>
                </c:pt>
                <c:pt idx="28">
                  <c:v>0.9446874259162705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HCC827'!$A$12</c:f>
              <c:strCache>
                <c:ptCount val="1"/>
                <c:pt idx="0">
                  <c:v>JNJ-BJ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HCC827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CC827'!$B$12:$AE$12</c:f>
              <c:numCache>
                <c:formatCode>General</c:formatCode>
                <c:ptCount val="30"/>
                <c:pt idx="0">
                  <c:v>0.97398528257359152</c:v>
                </c:pt>
                <c:pt idx="1">
                  <c:v>0.97398528257359152</c:v>
                </c:pt>
                <c:pt idx="2">
                  <c:v>0.97398528257359152</c:v>
                </c:pt>
                <c:pt idx="3">
                  <c:v>0.98415383863055195</c:v>
                </c:pt>
                <c:pt idx="4">
                  <c:v>0.98415383863055195</c:v>
                </c:pt>
                <c:pt idx="5">
                  <c:v>0.98415383863055195</c:v>
                </c:pt>
                <c:pt idx="6">
                  <c:v>0.96661849478329454</c:v>
                </c:pt>
                <c:pt idx="7">
                  <c:v>0.96661849478329454</c:v>
                </c:pt>
                <c:pt idx="8">
                  <c:v>0.96661849478329454</c:v>
                </c:pt>
                <c:pt idx="9">
                  <c:v>0.96557119967150196</c:v>
                </c:pt>
                <c:pt idx="10">
                  <c:v>0.96557119967150196</c:v>
                </c:pt>
                <c:pt idx="11">
                  <c:v>0.96557119967150196</c:v>
                </c:pt>
                <c:pt idx="12">
                  <c:v>0.96475237598220631</c:v>
                </c:pt>
                <c:pt idx="13">
                  <c:v>0.96475237598220631</c:v>
                </c:pt>
                <c:pt idx="14">
                  <c:v>0.96475237598220631</c:v>
                </c:pt>
                <c:pt idx="15">
                  <c:v>0.99062717063254013</c:v>
                </c:pt>
                <c:pt idx="16">
                  <c:v>0.99062717063254013</c:v>
                </c:pt>
                <c:pt idx="17">
                  <c:v>0.99062717063254013</c:v>
                </c:pt>
                <c:pt idx="18">
                  <c:v>0.97162343757027414</c:v>
                </c:pt>
                <c:pt idx="19">
                  <c:v>0.97162343757027414</c:v>
                </c:pt>
                <c:pt idx="20">
                  <c:v>0.97162343757027414</c:v>
                </c:pt>
                <c:pt idx="21">
                  <c:v>0.98034153380186928</c:v>
                </c:pt>
                <c:pt idx="22">
                  <c:v>0.98034153380186928</c:v>
                </c:pt>
                <c:pt idx="23">
                  <c:v>0.98034153380186928</c:v>
                </c:pt>
                <c:pt idx="24">
                  <c:v>0.98995403813434579</c:v>
                </c:pt>
                <c:pt idx="25">
                  <c:v>0.98995403813434579</c:v>
                </c:pt>
                <c:pt idx="26">
                  <c:v>0.98995403813434579</c:v>
                </c:pt>
                <c:pt idx="27">
                  <c:v>0.95614058148536896</c:v>
                </c:pt>
                <c:pt idx="28">
                  <c:v>0.95614058148536896</c:v>
                </c:pt>
                <c:pt idx="29">
                  <c:v>0.9561405814853689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208448"/>
        <c:axId val="83209024"/>
      </c:scatterChart>
      <c:valAx>
        <c:axId val="83208448"/>
        <c:scaling>
          <c:orientation val="minMax"/>
          <c:max val="11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crossAx val="83209024"/>
        <c:crosses val="autoZero"/>
        <c:crossBetween val="midCat"/>
        <c:majorUnit val="1"/>
      </c:valAx>
      <c:valAx>
        <c:axId val="8320902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8320844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H460'!$A$7</c:f>
              <c:strCache>
                <c:ptCount val="1"/>
                <c:pt idx="0">
                  <c:v>XAV939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460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460'!$B$7:$AE$7</c:f>
              <c:numCache>
                <c:formatCode>General</c:formatCode>
                <c:ptCount val="30"/>
                <c:pt idx="1">
                  <c:v>1.0194869346047748</c:v>
                </c:pt>
                <c:pt idx="4">
                  <c:v>1.0204437686660583</c:v>
                </c:pt>
                <c:pt idx="7">
                  <c:v>1.0049470662244702</c:v>
                </c:pt>
                <c:pt idx="10">
                  <c:v>1.0326680710409961</c:v>
                </c:pt>
                <c:pt idx="13">
                  <c:v>1.0424989844962209</c:v>
                </c:pt>
                <c:pt idx="16">
                  <c:v>1.0637110320985494</c:v>
                </c:pt>
                <c:pt idx="19">
                  <c:v>1.0322789157471766</c:v>
                </c:pt>
                <c:pt idx="22">
                  <c:v>1.0386159003046302</c:v>
                </c:pt>
                <c:pt idx="25">
                  <c:v>1.025368653132654</c:v>
                </c:pt>
                <c:pt idx="28">
                  <c:v>1.018568578030635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H460'!$A$8</c:f>
              <c:strCache>
                <c:ptCount val="1"/>
                <c:pt idx="0">
                  <c:v>XAV939 Average 2 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460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460'!$B$8:$AE$8</c:f>
              <c:numCache>
                <c:formatCode>General</c:formatCode>
                <c:ptCount val="30"/>
                <c:pt idx="1">
                  <c:v>0.99973234581520842</c:v>
                </c:pt>
                <c:pt idx="4">
                  <c:v>1.0195878443993025</c:v>
                </c:pt>
                <c:pt idx="7">
                  <c:v>1.023216714399098</c:v>
                </c:pt>
                <c:pt idx="10">
                  <c:v>1.0609450731488652</c:v>
                </c:pt>
                <c:pt idx="13">
                  <c:v>1.0502137461566374</c:v>
                </c:pt>
                <c:pt idx="16">
                  <c:v>1.0268967112436196</c:v>
                </c:pt>
                <c:pt idx="19">
                  <c:v>1.0275593051749867</c:v>
                </c:pt>
                <c:pt idx="22">
                  <c:v>1.0255019862861119</c:v>
                </c:pt>
                <c:pt idx="25">
                  <c:v>0.99280479069435323</c:v>
                </c:pt>
                <c:pt idx="28">
                  <c:v>0.9408288806284961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H460'!$A$9</c:f>
              <c:strCache>
                <c:ptCount val="1"/>
                <c:pt idx="0">
                  <c:v>XAV939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H460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460'!$B$9:$AE$9</c:f>
              <c:numCache>
                <c:formatCode>General</c:formatCode>
                <c:ptCount val="30"/>
                <c:pt idx="0">
                  <c:v>1.0096096402099917</c:v>
                </c:pt>
                <c:pt idx="1">
                  <c:v>1.0096096402099917</c:v>
                </c:pt>
                <c:pt idx="2">
                  <c:v>1.0096096402099917</c:v>
                </c:pt>
                <c:pt idx="3">
                  <c:v>1.0200158065326805</c:v>
                </c:pt>
                <c:pt idx="4">
                  <c:v>1.0200158065326805</c:v>
                </c:pt>
                <c:pt idx="5">
                  <c:v>1.0200158065326805</c:v>
                </c:pt>
                <c:pt idx="6">
                  <c:v>1.0140818903117841</c:v>
                </c:pt>
                <c:pt idx="7">
                  <c:v>1.0140818903117841</c:v>
                </c:pt>
                <c:pt idx="8">
                  <c:v>1.0140818903117841</c:v>
                </c:pt>
                <c:pt idx="9">
                  <c:v>1.0468065720949307</c:v>
                </c:pt>
                <c:pt idx="10">
                  <c:v>1.0468065720949307</c:v>
                </c:pt>
                <c:pt idx="11">
                  <c:v>1.0468065720949307</c:v>
                </c:pt>
                <c:pt idx="12">
                  <c:v>1.0463563653264292</c:v>
                </c:pt>
                <c:pt idx="13">
                  <c:v>1.0463563653264292</c:v>
                </c:pt>
                <c:pt idx="14">
                  <c:v>1.0463563653264292</c:v>
                </c:pt>
                <c:pt idx="15">
                  <c:v>1.0453038716710845</c:v>
                </c:pt>
                <c:pt idx="16">
                  <c:v>1.0453038716710845</c:v>
                </c:pt>
                <c:pt idx="17">
                  <c:v>1.0453038716710845</c:v>
                </c:pt>
                <c:pt idx="18">
                  <c:v>1.0299191104610816</c:v>
                </c:pt>
                <c:pt idx="19">
                  <c:v>1.0299191104610816</c:v>
                </c:pt>
                <c:pt idx="20">
                  <c:v>1.0299191104610816</c:v>
                </c:pt>
                <c:pt idx="21">
                  <c:v>1.0320589432953711</c:v>
                </c:pt>
                <c:pt idx="22">
                  <c:v>1.0320589432953711</c:v>
                </c:pt>
                <c:pt idx="23">
                  <c:v>1.0320589432953711</c:v>
                </c:pt>
                <c:pt idx="24">
                  <c:v>1.0090867219135036</c:v>
                </c:pt>
                <c:pt idx="25">
                  <c:v>1.0090867219135036</c:v>
                </c:pt>
                <c:pt idx="26">
                  <c:v>1.0090867219135036</c:v>
                </c:pt>
                <c:pt idx="27">
                  <c:v>0.97969872932956603</c:v>
                </c:pt>
                <c:pt idx="28">
                  <c:v>0.97969872932956603</c:v>
                </c:pt>
                <c:pt idx="29">
                  <c:v>0.979698729329566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210752"/>
        <c:axId val="83212480"/>
      </c:scatterChart>
      <c:valAx>
        <c:axId val="83210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83212480"/>
        <c:crosses val="autoZero"/>
        <c:crossBetween val="midCat"/>
        <c:majorUnit val="1"/>
      </c:valAx>
      <c:valAx>
        <c:axId val="8321248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8321075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H460'!$A$10</c:f>
              <c:strCache>
                <c:ptCount val="1"/>
                <c:pt idx="0">
                  <c:v>JNJ-BJ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460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460'!$B$10:$AE$10</c:f>
              <c:numCache>
                <c:formatCode>General</c:formatCode>
                <c:ptCount val="30"/>
                <c:pt idx="1">
                  <c:v>1.0201812211165502</c:v>
                </c:pt>
                <c:pt idx="4">
                  <c:v>1.0257749910855734</c:v>
                </c:pt>
                <c:pt idx="7">
                  <c:v>1.0142391868240619</c:v>
                </c:pt>
                <c:pt idx="10">
                  <c:v>1.0338325841253302</c:v>
                </c:pt>
                <c:pt idx="13">
                  <c:v>1.0325392282891381</c:v>
                </c:pt>
                <c:pt idx="16">
                  <c:v>1.0478950315011091</c:v>
                </c:pt>
                <c:pt idx="19">
                  <c:v>1.0102324683389716</c:v>
                </c:pt>
                <c:pt idx="22">
                  <c:v>1.0296249692973385</c:v>
                </c:pt>
                <c:pt idx="25">
                  <c:v>1.0172553284597505</c:v>
                </c:pt>
                <c:pt idx="28">
                  <c:v>1.007602593811481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H460'!$A$11</c:f>
              <c:strCache>
                <c:ptCount val="1"/>
                <c:pt idx="0">
                  <c:v>JNJ-BJ Average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460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460'!$B$11:$AE$11</c:f>
              <c:numCache>
                <c:formatCode>General</c:formatCode>
                <c:ptCount val="30"/>
                <c:pt idx="1">
                  <c:v>0.98348141572917469</c:v>
                </c:pt>
                <c:pt idx="4">
                  <c:v>0.98692474286708021</c:v>
                </c:pt>
                <c:pt idx="7">
                  <c:v>0.98555514596888749</c:v>
                </c:pt>
                <c:pt idx="10">
                  <c:v>0.98977730892185001</c:v>
                </c:pt>
                <c:pt idx="13">
                  <c:v>0.97833244231457217</c:v>
                </c:pt>
                <c:pt idx="16">
                  <c:v>0.96751259048713445</c:v>
                </c:pt>
                <c:pt idx="19">
                  <c:v>0.96550737004113285</c:v>
                </c:pt>
                <c:pt idx="22">
                  <c:v>0.97356206798125133</c:v>
                </c:pt>
                <c:pt idx="25">
                  <c:v>0.92175156446778295</c:v>
                </c:pt>
                <c:pt idx="28">
                  <c:v>0.8606878715853710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H460'!$A$12</c:f>
              <c:strCache>
                <c:ptCount val="1"/>
                <c:pt idx="0">
                  <c:v>JNJ-BJ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H460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460'!$B$12:$AE$12</c:f>
              <c:numCache>
                <c:formatCode>General</c:formatCode>
                <c:ptCount val="30"/>
                <c:pt idx="0">
                  <c:v>1.0018313184228624</c:v>
                </c:pt>
                <c:pt idx="1">
                  <c:v>1.0018313184228624</c:v>
                </c:pt>
                <c:pt idx="2">
                  <c:v>1.0018313184228624</c:v>
                </c:pt>
                <c:pt idx="3">
                  <c:v>1.0063498669763269</c:v>
                </c:pt>
                <c:pt idx="4">
                  <c:v>1.0063498669763269</c:v>
                </c:pt>
                <c:pt idx="5">
                  <c:v>1.0063498669763269</c:v>
                </c:pt>
                <c:pt idx="6">
                  <c:v>0.99989716639647463</c:v>
                </c:pt>
                <c:pt idx="7">
                  <c:v>0.99989716639647463</c:v>
                </c:pt>
                <c:pt idx="8">
                  <c:v>0.99989716639647463</c:v>
                </c:pt>
                <c:pt idx="9">
                  <c:v>1.0118049465235901</c:v>
                </c:pt>
                <c:pt idx="10">
                  <c:v>1.0118049465235901</c:v>
                </c:pt>
                <c:pt idx="11">
                  <c:v>1.0118049465235901</c:v>
                </c:pt>
                <c:pt idx="12">
                  <c:v>1.0054358353018551</c:v>
                </c:pt>
                <c:pt idx="13">
                  <c:v>1.0054358353018551</c:v>
                </c:pt>
                <c:pt idx="14">
                  <c:v>1.0054358353018551</c:v>
                </c:pt>
                <c:pt idx="15">
                  <c:v>1.0077038109941219</c:v>
                </c:pt>
                <c:pt idx="16">
                  <c:v>1.0077038109941219</c:v>
                </c:pt>
                <c:pt idx="17">
                  <c:v>1.0077038109941219</c:v>
                </c:pt>
                <c:pt idx="18">
                  <c:v>0.98786991919005218</c:v>
                </c:pt>
                <c:pt idx="19">
                  <c:v>0.98786991919005218</c:v>
                </c:pt>
                <c:pt idx="20">
                  <c:v>0.98786991919005218</c:v>
                </c:pt>
                <c:pt idx="21">
                  <c:v>1.0015935186392948</c:v>
                </c:pt>
                <c:pt idx="22">
                  <c:v>1.0015935186392948</c:v>
                </c:pt>
                <c:pt idx="23">
                  <c:v>1.0015935186392948</c:v>
                </c:pt>
                <c:pt idx="24">
                  <c:v>0.96950344646376674</c:v>
                </c:pt>
                <c:pt idx="25">
                  <c:v>0.96950344646376674</c:v>
                </c:pt>
                <c:pt idx="26">
                  <c:v>0.96950344646376674</c:v>
                </c:pt>
                <c:pt idx="27">
                  <c:v>0.93414523269842609</c:v>
                </c:pt>
                <c:pt idx="28">
                  <c:v>0.93414523269842609</c:v>
                </c:pt>
                <c:pt idx="29">
                  <c:v>0.934145232698426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676800"/>
        <c:axId val="107677376"/>
      </c:scatterChart>
      <c:valAx>
        <c:axId val="107676800"/>
        <c:scaling>
          <c:orientation val="minMax"/>
          <c:max val="11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crossAx val="107677376"/>
        <c:crosses val="autoZero"/>
        <c:crossBetween val="midCat"/>
        <c:majorUnit val="1"/>
      </c:valAx>
      <c:valAx>
        <c:axId val="10767737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0767680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H322'!$A$7</c:f>
              <c:strCache>
                <c:ptCount val="1"/>
                <c:pt idx="0">
                  <c:v>XAV939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322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322'!$B$7:$AE$7</c:f>
              <c:numCache>
                <c:formatCode>General</c:formatCode>
                <c:ptCount val="30"/>
                <c:pt idx="1">
                  <c:v>1.0051909614035792</c:v>
                </c:pt>
                <c:pt idx="4">
                  <c:v>0.98291436169405921</c:v>
                </c:pt>
                <c:pt idx="7">
                  <c:v>0.98564146944544895</c:v>
                </c:pt>
                <c:pt idx="10">
                  <c:v>0.95920649338627806</c:v>
                </c:pt>
                <c:pt idx="13">
                  <c:v>0.94305652041666743</c:v>
                </c:pt>
                <c:pt idx="16">
                  <c:v>0.91426819019430372</c:v>
                </c:pt>
                <c:pt idx="19">
                  <c:v>0.90060453442478661</c:v>
                </c:pt>
                <c:pt idx="22">
                  <c:v>0.90084507397222735</c:v>
                </c:pt>
                <c:pt idx="25">
                  <c:v>0.87058078424720153</c:v>
                </c:pt>
                <c:pt idx="28">
                  <c:v>0.8862190704667395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H322'!$A$8</c:f>
              <c:strCache>
                <c:ptCount val="1"/>
                <c:pt idx="0">
                  <c:v>XAV939 Average 2 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322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322'!$B$8:$AE$8</c:f>
              <c:numCache>
                <c:formatCode>General</c:formatCode>
                <c:ptCount val="30"/>
                <c:pt idx="1">
                  <c:v>0.98828541868072073</c:v>
                </c:pt>
                <c:pt idx="4">
                  <c:v>0.97785476734810461</c:v>
                </c:pt>
                <c:pt idx="7">
                  <c:v>0.93587049322158378</c:v>
                </c:pt>
                <c:pt idx="10">
                  <c:v>0.95466977623166194</c:v>
                </c:pt>
                <c:pt idx="13">
                  <c:v>0.93905976958941251</c:v>
                </c:pt>
                <c:pt idx="16">
                  <c:v>0.93087885308601259</c:v>
                </c:pt>
                <c:pt idx="19">
                  <c:v>0.94348576265427908</c:v>
                </c:pt>
                <c:pt idx="22">
                  <c:v>0.96241171156309213</c:v>
                </c:pt>
                <c:pt idx="25">
                  <c:v>0.8923032066703882</c:v>
                </c:pt>
                <c:pt idx="28">
                  <c:v>0.899437085742644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H322'!$A$9</c:f>
              <c:strCache>
                <c:ptCount val="1"/>
                <c:pt idx="0">
                  <c:v>XAV939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H322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322'!$B$9:$AE$9</c:f>
              <c:numCache>
                <c:formatCode>General</c:formatCode>
                <c:ptCount val="30"/>
                <c:pt idx="0">
                  <c:v>0.99673819004214992</c:v>
                </c:pt>
                <c:pt idx="1">
                  <c:v>0.99673819004214992</c:v>
                </c:pt>
                <c:pt idx="2">
                  <c:v>0.99673819004214992</c:v>
                </c:pt>
                <c:pt idx="3">
                  <c:v>0.98038456452108191</c:v>
                </c:pt>
                <c:pt idx="4">
                  <c:v>0.98038456452108191</c:v>
                </c:pt>
                <c:pt idx="5">
                  <c:v>0.98038456452108191</c:v>
                </c:pt>
                <c:pt idx="6">
                  <c:v>0.96075598133351636</c:v>
                </c:pt>
                <c:pt idx="7">
                  <c:v>0.96075598133351636</c:v>
                </c:pt>
                <c:pt idx="8">
                  <c:v>0.96075598133351636</c:v>
                </c:pt>
                <c:pt idx="9">
                  <c:v>0.95693813480897005</c:v>
                </c:pt>
                <c:pt idx="10">
                  <c:v>0.95693813480897005</c:v>
                </c:pt>
                <c:pt idx="11">
                  <c:v>0.95693813480897005</c:v>
                </c:pt>
                <c:pt idx="12">
                  <c:v>0.94105814500303997</c:v>
                </c:pt>
                <c:pt idx="13">
                  <c:v>0.94105814500303997</c:v>
                </c:pt>
                <c:pt idx="14">
                  <c:v>0.94105814500303997</c:v>
                </c:pt>
                <c:pt idx="15">
                  <c:v>0.92257352164015816</c:v>
                </c:pt>
                <c:pt idx="16">
                  <c:v>0.92257352164015816</c:v>
                </c:pt>
                <c:pt idx="17">
                  <c:v>0.92257352164015816</c:v>
                </c:pt>
                <c:pt idx="18">
                  <c:v>0.9220451485395329</c:v>
                </c:pt>
                <c:pt idx="19">
                  <c:v>0.9220451485395329</c:v>
                </c:pt>
                <c:pt idx="20">
                  <c:v>0.9220451485395329</c:v>
                </c:pt>
                <c:pt idx="21">
                  <c:v>0.93162839276765974</c:v>
                </c:pt>
                <c:pt idx="22">
                  <c:v>0.93162839276765974</c:v>
                </c:pt>
                <c:pt idx="23">
                  <c:v>0.93162839276765974</c:v>
                </c:pt>
                <c:pt idx="24">
                  <c:v>0.88144199545879487</c:v>
                </c:pt>
                <c:pt idx="25">
                  <c:v>0.88144199545879487</c:v>
                </c:pt>
                <c:pt idx="26">
                  <c:v>0.88144199545879487</c:v>
                </c:pt>
                <c:pt idx="27">
                  <c:v>0.89282807810469222</c:v>
                </c:pt>
                <c:pt idx="28">
                  <c:v>0.89282807810469222</c:v>
                </c:pt>
                <c:pt idx="29">
                  <c:v>0.8928280781046922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679104"/>
        <c:axId val="107679680"/>
      </c:scatterChart>
      <c:valAx>
        <c:axId val="107679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107679680"/>
        <c:crosses val="autoZero"/>
        <c:crossBetween val="midCat"/>
        <c:majorUnit val="1"/>
      </c:valAx>
      <c:valAx>
        <c:axId val="10767968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07679104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H322'!$A$10</c:f>
              <c:strCache>
                <c:ptCount val="1"/>
                <c:pt idx="0">
                  <c:v>JNJ-BJ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322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322'!$B$10:$AE$10</c:f>
              <c:numCache>
                <c:formatCode>General</c:formatCode>
                <c:ptCount val="30"/>
                <c:pt idx="1">
                  <c:v>0.96063408170268394</c:v>
                </c:pt>
                <c:pt idx="4">
                  <c:v>1.0201552319484009</c:v>
                </c:pt>
                <c:pt idx="7">
                  <c:v>0.99807075846915949</c:v>
                </c:pt>
                <c:pt idx="10">
                  <c:v>0.95041883319485687</c:v>
                </c:pt>
                <c:pt idx="13">
                  <c:v>0.9366887122430817</c:v>
                </c:pt>
                <c:pt idx="16">
                  <c:v>0.93551792122744981</c:v>
                </c:pt>
                <c:pt idx="19">
                  <c:v>0.89312383222344915</c:v>
                </c:pt>
                <c:pt idx="22">
                  <c:v>0.92652491577496887</c:v>
                </c:pt>
                <c:pt idx="25">
                  <c:v>0.87975235053683443</c:v>
                </c:pt>
                <c:pt idx="28">
                  <c:v>0.7596176060970993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H322'!$A$11</c:f>
              <c:strCache>
                <c:ptCount val="1"/>
                <c:pt idx="0">
                  <c:v>JNJ-BJ Average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H322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322'!$B$11:$AE$11</c:f>
              <c:numCache>
                <c:formatCode>General</c:formatCode>
                <c:ptCount val="30"/>
                <c:pt idx="1">
                  <c:v>0.96571466794004257</c:v>
                </c:pt>
                <c:pt idx="4">
                  <c:v>0.97458184900111311</c:v>
                </c:pt>
                <c:pt idx="7">
                  <c:v>0.93283124670657303</c:v>
                </c:pt>
                <c:pt idx="10">
                  <c:v>1.0094053980469206</c:v>
                </c:pt>
                <c:pt idx="13">
                  <c:v>0.97835792883370676</c:v>
                </c:pt>
                <c:pt idx="16">
                  <c:v>0.96476562207953731</c:v>
                </c:pt>
                <c:pt idx="19">
                  <c:v>0.94233715542889285</c:v>
                </c:pt>
                <c:pt idx="22">
                  <c:v>0.97643531138777739</c:v>
                </c:pt>
                <c:pt idx="25">
                  <c:v>0.93111142826370608</c:v>
                </c:pt>
                <c:pt idx="28">
                  <c:v>0.9265004610654079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H322'!$A$12</c:f>
              <c:strCache>
                <c:ptCount val="1"/>
                <c:pt idx="0">
                  <c:v>JNJ-BJ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H322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H322'!$B$12:$AE$12</c:f>
              <c:numCache>
                <c:formatCode>General</c:formatCode>
                <c:ptCount val="30"/>
                <c:pt idx="0">
                  <c:v>0.96317437482136325</c:v>
                </c:pt>
                <c:pt idx="1">
                  <c:v>0.96317437482136325</c:v>
                </c:pt>
                <c:pt idx="2">
                  <c:v>0.96317437482136325</c:v>
                </c:pt>
                <c:pt idx="3">
                  <c:v>0.99736854047475698</c:v>
                </c:pt>
                <c:pt idx="4">
                  <c:v>0.99736854047475698</c:v>
                </c:pt>
                <c:pt idx="5">
                  <c:v>0.99736854047475698</c:v>
                </c:pt>
                <c:pt idx="6">
                  <c:v>0.9654510025878662</c:v>
                </c:pt>
                <c:pt idx="7">
                  <c:v>0.9654510025878662</c:v>
                </c:pt>
                <c:pt idx="8">
                  <c:v>0.9654510025878662</c:v>
                </c:pt>
                <c:pt idx="9">
                  <c:v>0.97991211562088876</c:v>
                </c:pt>
                <c:pt idx="10">
                  <c:v>0.97991211562088876</c:v>
                </c:pt>
                <c:pt idx="11">
                  <c:v>0.97991211562088876</c:v>
                </c:pt>
                <c:pt idx="12">
                  <c:v>0.95752332053839417</c:v>
                </c:pt>
                <c:pt idx="13">
                  <c:v>0.95752332053839417</c:v>
                </c:pt>
                <c:pt idx="14">
                  <c:v>0.95752332053839417</c:v>
                </c:pt>
                <c:pt idx="15">
                  <c:v>0.95014177165349356</c:v>
                </c:pt>
                <c:pt idx="16">
                  <c:v>0.95014177165349356</c:v>
                </c:pt>
                <c:pt idx="17">
                  <c:v>0.95014177165349356</c:v>
                </c:pt>
                <c:pt idx="18">
                  <c:v>0.917730493826171</c:v>
                </c:pt>
                <c:pt idx="19">
                  <c:v>0.917730493826171</c:v>
                </c:pt>
                <c:pt idx="20">
                  <c:v>0.917730493826171</c:v>
                </c:pt>
                <c:pt idx="21">
                  <c:v>0.95148011358137308</c:v>
                </c:pt>
                <c:pt idx="22">
                  <c:v>0.95148011358137308</c:v>
                </c:pt>
                <c:pt idx="23">
                  <c:v>0.95148011358137308</c:v>
                </c:pt>
                <c:pt idx="24">
                  <c:v>0.9054318894002702</c:v>
                </c:pt>
                <c:pt idx="25">
                  <c:v>0.9054318894002702</c:v>
                </c:pt>
                <c:pt idx="26">
                  <c:v>0.9054318894002702</c:v>
                </c:pt>
                <c:pt idx="27">
                  <c:v>0.84305903358125367</c:v>
                </c:pt>
                <c:pt idx="28">
                  <c:v>0.84305903358125367</c:v>
                </c:pt>
                <c:pt idx="29">
                  <c:v>0.843059033581253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7681408"/>
        <c:axId val="107681984"/>
      </c:scatterChart>
      <c:valAx>
        <c:axId val="107681408"/>
        <c:scaling>
          <c:orientation val="minMax"/>
          <c:max val="11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crossAx val="107681984"/>
        <c:crosses val="autoZero"/>
        <c:crossBetween val="midCat"/>
        <c:majorUnit val="1"/>
      </c:valAx>
      <c:valAx>
        <c:axId val="1076819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0768140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A549'!$A$7</c:f>
              <c:strCache>
                <c:ptCount val="1"/>
                <c:pt idx="0">
                  <c:v>XAV939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A549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A549'!$B$7:$AE$7</c:f>
              <c:numCache>
                <c:formatCode>General</c:formatCode>
                <c:ptCount val="30"/>
                <c:pt idx="1">
                  <c:v>1.0168285931067829</c:v>
                </c:pt>
                <c:pt idx="4">
                  <c:v>0.99298638647152093</c:v>
                </c:pt>
                <c:pt idx="7">
                  <c:v>1.0182986053783245</c:v>
                </c:pt>
                <c:pt idx="10">
                  <c:v>1.0073402776228104</c:v>
                </c:pt>
                <c:pt idx="13">
                  <c:v>0.95969212650773916</c:v>
                </c:pt>
                <c:pt idx="16">
                  <c:v>0.93067826941490495</c:v>
                </c:pt>
                <c:pt idx="19">
                  <c:v>0.88246475355488907</c:v>
                </c:pt>
                <c:pt idx="22">
                  <c:v>0.85709065995191502</c:v>
                </c:pt>
                <c:pt idx="25">
                  <c:v>0.83168400526743747</c:v>
                </c:pt>
                <c:pt idx="28">
                  <c:v>0.7902356199989467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A549'!$A$8</c:f>
              <c:strCache>
                <c:ptCount val="1"/>
                <c:pt idx="0">
                  <c:v>XAV939 Average 2 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A549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A549'!$B$8:$AE$8</c:f>
              <c:numCache>
                <c:formatCode>General</c:formatCode>
                <c:ptCount val="30"/>
                <c:pt idx="1">
                  <c:v>0.98232653619201815</c:v>
                </c:pt>
                <c:pt idx="4">
                  <c:v>0.98278896822556217</c:v>
                </c:pt>
                <c:pt idx="7">
                  <c:v>0.97782540816399699</c:v>
                </c:pt>
                <c:pt idx="10">
                  <c:v>0.97662176899015307</c:v>
                </c:pt>
                <c:pt idx="13">
                  <c:v>0.96216314641081435</c:v>
                </c:pt>
                <c:pt idx="16">
                  <c:v>0.94713583269458201</c:v>
                </c:pt>
                <c:pt idx="19">
                  <c:v>0.93168133196628</c:v>
                </c:pt>
                <c:pt idx="22">
                  <c:v>0.94407401138802183</c:v>
                </c:pt>
                <c:pt idx="25">
                  <c:v>0.89944854701138666</c:v>
                </c:pt>
                <c:pt idx="28">
                  <c:v>0.8566669708883433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A549'!$A$9</c:f>
              <c:strCache>
                <c:ptCount val="1"/>
                <c:pt idx="0">
                  <c:v>XAV939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A549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A549'!$B$9:$AE$9</c:f>
              <c:numCache>
                <c:formatCode>General</c:formatCode>
                <c:ptCount val="30"/>
                <c:pt idx="0">
                  <c:v>0.99957756464940051</c:v>
                </c:pt>
                <c:pt idx="1">
                  <c:v>0.99957756464940051</c:v>
                </c:pt>
                <c:pt idx="2">
                  <c:v>0.99957756464940051</c:v>
                </c:pt>
                <c:pt idx="3">
                  <c:v>0.98788767734854155</c:v>
                </c:pt>
                <c:pt idx="4">
                  <c:v>0.98788767734854155</c:v>
                </c:pt>
                <c:pt idx="5">
                  <c:v>0.98788767734854155</c:v>
                </c:pt>
                <c:pt idx="6">
                  <c:v>0.99806200677116075</c:v>
                </c:pt>
                <c:pt idx="7">
                  <c:v>0.99806200677116075</c:v>
                </c:pt>
                <c:pt idx="8">
                  <c:v>0.99806200677116075</c:v>
                </c:pt>
                <c:pt idx="9">
                  <c:v>0.99198102330648175</c:v>
                </c:pt>
                <c:pt idx="10">
                  <c:v>0.99198102330648175</c:v>
                </c:pt>
                <c:pt idx="11">
                  <c:v>0.99198102330648175</c:v>
                </c:pt>
                <c:pt idx="12">
                  <c:v>0.9609276364592767</c:v>
                </c:pt>
                <c:pt idx="13">
                  <c:v>0.9609276364592767</c:v>
                </c:pt>
                <c:pt idx="14">
                  <c:v>0.9609276364592767</c:v>
                </c:pt>
                <c:pt idx="15">
                  <c:v>0.93890705105474348</c:v>
                </c:pt>
                <c:pt idx="16">
                  <c:v>0.93890705105474348</c:v>
                </c:pt>
                <c:pt idx="17">
                  <c:v>0.93890705105474348</c:v>
                </c:pt>
                <c:pt idx="18">
                  <c:v>0.90707304276058454</c:v>
                </c:pt>
                <c:pt idx="19">
                  <c:v>0.90707304276058454</c:v>
                </c:pt>
                <c:pt idx="20">
                  <c:v>0.90707304276058454</c:v>
                </c:pt>
                <c:pt idx="21">
                  <c:v>0.90058233566996848</c:v>
                </c:pt>
                <c:pt idx="22">
                  <c:v>0.90058233566996848</c:v>
                </c:pt>
                <c:pt idx="23">
                  <c:v>0.90058233566996848</c:v>
                </c:pt>
                <c:pt idx="24">
                  <c:v>0.86556627613941206</c:v>
                </c:pt>
                <c:pt idx="25">
                  <c:v>0.86556627613941206</c:v>
                </c:pt>
                <c:pt idx="26">
                  <c:v>0.86556627613941206</c:v>
                </c:pt>
                <c:pt idx="27">
                  <c:v>0.82345129544364504</c:v>
                </c:pt>
                <c:pt idx="28">
                  <c:v>0.82345129544364504</c:v>
                </c:pt>
                <c:pt idx="29">
                  <c:v>0.823451295443645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8855296"/>
        <c:axId val="108856448"/>
      </c:scatterChart>
      <c:valAx>
        <c:axId val="108855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108856448"/>
        <c:crosses val="autoZero"/>
        <c:crossBetween val="midCat"/>
        <c:majorUnit val="1"/>
      </c:valAx>
      <c:valAx>
        <c:axId val="10885644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0885529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Additional File 6_Fig.S2 A549'!$A$10</c:f>
              <c:strCache>
                <c:ptCount val="1"/>
                <c:pt idx="0">
                  <c:v>JNJ-BJ 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A549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A549'!$B$10:$AE$10</c:f>
              <c:numCache>
                <c:formatCode>General</c:formatCode>
                <c:ptCount val="30"/>
                <c:pt idx="1">
                  <c:v>1.0341773006824331</c:v>
                </c:pt>
                <c:pt idx="4">
                  <c:v>0.98833216216617026</c:v>
                </c:pt>
                <c:pt idx="7">
                  <c:v>1.0092102553127273</c:v>
                </c:pt>
                <c:pt idx="10">
                  <c:v>0.98920131471214345</c:v>
                </c:pt>
                <c:pt idx="13">
                  <c:v>0.9791961596183052</c:v>
                </c:pt>
                <c:pt idx="16">
                  <c:v>1.0049613026465973</c:v>
                </c:pt>
                <c:pt idx="19">
                  <c:v>0.99868412167848408</c:v>
                </c:pt>
                <c:pt idx="22">
                  <c:v>0.95607437582362031</c:v>
                </c:pt>
                <c:pt idx="25">
                  <c:v>0.88195165703039935</c:v>
                </c:pt>
                <c:pt idx="28">
                  <c:v>0.830300154137438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Additional File 6_Fig.S2 A549'!$A$11</c:f>
              <c:strCache>
                <c:ptCount val="1"/>
                <c:pt idx="0">
                  <c:v>JNJ-BJ Average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Additional File 6_Fig.S2 A549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A549'!$B$11:$AE$11</c:f>
              <c:numCache>
                <c:formatCode>General</c:formatCode>
                <c:ptCount val="30"/>
                <c:pt idx="1">
                  <c:v>0.96229306395377112</c:v>
                </c:pt>
                <c:pt idx="4">
                  <c:v>0.98408007178460088</c:v>
                </c:pt>
                <c:pt idx="7">
                  <c:v>0.97606389592240139</c:v>
                </c:pt>
                <c:pt idx="10">
                  <c:v>0.97262755384008148</c:v>
                </c:pt>
                <c:pt idx="13">
                  <c:v>0.96472070176587987</c:v>
                </c:pt>
                <c:pt idx="16">
                  <c:v>0.97714651254220408</c:v>
                </c:pt>
                <c:pt idx="19">
                  <c:v>0.94518799151291533</c:v>
                </c:pt>
                <c:pt idx="22">
                  <c:v>0.95491296002833725</c:v>
                </c:pt>
                <c:pt idx="25">
                  <c:v>0.89321175747937298</c:v>
                </c:pt>
                <c:pt idx="28">
                  <c:v>0.8187791120907178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Additional File 6_Fig.S2 A549'!$A$12</c:f>
              <c:strCache>
                <c:ptCount val="1"/>
                <c:pt idx="0">
                  <c:v>JNJ-BJ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Additional File 6_Fig.S2 A549'!$B$6:$AE$6</c:f>
              <c:numCache>
                <c:formatCode>General</c:formatCode>
                <c:ptCount val="30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  <c:pt idx="9">
                  <c:v>3.9</c:v>
                </c:pt>
                <c:pt idx="10">
                  <c:v>4</c:v>
                </c:pt>
                <c:pt idx="11">
                  <c:v>4.0999999999999996</c:v>
                </c:pt>
                <c:pt idx="12">
                  <c:v>4.9000000000000004</c:v>
                </c:pt>
                <c:pt idx="13">
                  <c:v>5</c:v>
                </c:pt>
                <c:pt idx="14">
                  <c:v>5.0999999999999996</c:v>
                </c:pt>
                <c:pt idx="15">
                  <c:v>5.9</c:v>
                </c:pt>
                <c:pt idx="16">
                  <c:v>6</c:v>
                </c:pt>
                <c:pt idx="17">
                  <c:v>6.1</c:v>
                </c:pt>
                <c:pt idx="18">
                  <c:v>6.9</c:v>
                </c:pt>
                <c:pt idx="19">
                  <c:v>7</c:v>
                </c:pt>
                <c:pt idx="20">
                  <c:v>7.1</c:v>
                </c:pt>
                <c:pt idx="21">
                  <c:v>7.9</c:v>
                </c:pt>
                <c:pt idx="22">
                  <c:v>8</c:v>
                </c:pt>
                <c:pt idx="23">
                  <c:v>8.1</c:v>
                </c:pt>
                <c:pt idx="24">
                  <c:v>8.9</c:v>
                </c:pt>
                <c:pt idx="25">
                  <c:v>9</c:v>
                </c:pt>
                <c:pt idx="26">
                  <c:v>9.1</c:v>
                </c:pt>
                <c:pt idx="27">
                  <c:v>9.9</c:v>
                </c:pt>
                <c:pt idx="28">
                  <c:v>10</c:v>
                </c:pt>
                <c:pt idx="29">
                  <c:v>10.1</c:v>
                </c:pt>
              </c:numCache>
            </c:numRef>
          </c:xVal>
          <c:yVal>
            <c:numRef>
              <c:f>'Additional File 6_Fig.S2 A549'!$B$12:$AE$12</c:f>
              <c:numCache>
                <c:formatCode>General</c:formatCode>
                <c:ptCount val="30"/>
                <c:pt idx="0">
                  <c:v>0.99823518231810215</c:v>
                </c:pt>
                <c:pt idx="1">
                  <c:v>0.99823518231810215</c:v>
                </c:pt>
                <c:pt idx="2">
                  <c:v>0.99823518231810215</c:v>
                </c:pt>
                <c:pt idx="3">
                  <c:v>0.98620611697538552</c:v>
                </c:pt>
                <c:pt idx="4">
                  <c:v>0.98620611697538552</c:v>
                </c:pt>
                <c:pt idx="5">
                  <c:v>0.98620611697538552</c:v>
                </c:pt>
                <c:pt idx="6">
                  <c:v>0.99263707561756442</c:v>
                </c:pt>
                <c:pt idx="7">
                  <c:v>0.99263707561756442</c:v>
                </c:pt>
                <c:pt idx="8">
                  <c:v>0.99263707561756442</c:v>
                </c:pt>
                <c:pt idx="9">
                  <c:v>0.98091443427611247</c:v>
                </c:pt>
                <c:pt idx="10">
                  <c:v>0.98091443427611247</c:v>
                </c:pt>
                <c:pt idx="11">
                  <c:v>0.98091443427611247</c:v>
                </c:pt>
                <c:pt idx="12">
                  <c:v>0.97195843069209253</c:v>
                </c:pt>
                <c:pt idx="13">
                  <c:v>0.97195843069209253</c:v>
                </c:pt>
                <c:pt idx="14">
                  <c:v>0.97195843069209253</c:v>
                </c:pt>
                <c:pt idx="15">
                  <c:v>0.99105390759440071</c:v>
                </c:pt>
                <c:pt idx="16">
                  <c:v>0.99105390759440071</c:v>
                </c:pt>
                <c:pt idx="17">
                  <c:v>0.99105390759440071</c:v>
                </c:pt>
                <c:pt idx="18">
                  <c:v>0.9719360565956997</c:v>
                </c:pt>
                <c:pt idx="19">
                  <c:v>0.9719360565956997</c:v>
                </c:pt>
                <c:pt idx="20">
                  <c:v>0.9719360565956997</c:v>
                </c:pt>
                <c:pt idx="21">
                  <c:v>0.95549366792597878</c:v>
                </c:pt>
                <c:pt idx="22">
                  <c:v>0.95549366792597878</c:v>
                </c:pt>
                <c:pt idx="23">
                  <c:v>0.95549366792597878</c:v>
                </c:pt>
                <c:pt idx="24">
                  <c:v>0.88758170725488617</c:v>
                </c:pt>
                <c:pt idx="25">
                  <c:v>0.88758170725488617</c:v>
                </c:pt>
                <c:pt idx="26">
                  <c:v>0.88758170725488617</c:v>
                </c:pt>
                <c:pt idx="27">
                  <c:v>0.82453963311407807</c:v>
                </c:pt>
                <c:pt idx="28">
                  <c:v>0.82453963311407807</c:v>
                </c:pt>
                <c:pt idx="29">
                  <c:v>0.824539633114078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8858176"/>
        <c:axId val="108858752"/>
      </c:scatterChart>
      <c:valAx>
        <c:axId val="108858176"/>
        <c:scaling>
          <c:orientation val="minMax"/>
          <c:max val="11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crossAx val="108858752"/>
        <c:crosses val="autoZero"/>
        <c:crossBetween val="midCat"/>
        <c:majorUnit val="1"/>
      </c:valAx>
      <c:valAx>
        <c:axId val="10885875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10885817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9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pPr/>
              <a:t>14/12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9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pPr/>
              <a:t>14/12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744538"/>
            <a:ext cx="25749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26">
              <a:defRPr/>
            </a:pPr>
            <a:endParaRPr lang="it-IT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12508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 Box 51"/>
          <p:cNvSpPr txBox="1">
            <a:spLocks noChangeArrowheads="1"/>
          </p:cNvSpPr>
          <p:nvPr/>
        </p:nvSpPr>
        <p:spPr bwMode="auto">
          <a:xfrm rot="16200000">
            <a:off x="-201644" y="1336512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51"/>
          <p:cNvSpPr txBox="1">
            <a:spLocks noChangeArrowheads="1"/>
          </p:cNvSpPr>
          <p:nvPr/>
        </p:nvSpPr>
        <p:spPr bwMode="auto">
          <a:xfrm rot="16200000">
            <a:off x="2960887" y="1343417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 Box 51"/>
          <p:cNvSpPr txBox="1">
            <a:spLocks noChangeArrowheads="1"/>
          </p:cNvSpPr>
          <p:nvPr/>
        </p:nvSpPr>
        <p:spPr bwMode="auto">
          <a:xfrm rot="16200000">
            <a:off x="-201645" y="5723591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51"/>
          <p:cNvSpPr txBox="1">
            <a:spLocks noChangeArrowheads="1"/>
          </p:cNvSpPr>
          <p:nvPr/>
        </p:nvSpPr>
        <p:spPr bwMode="auto">
          <a:xfrm rot="16200000">
            <a:off x="-201645" y="3549466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 Box 26"/>
          <p:cNvSpPr txBox="1">
            <a:spLocks noChangeArrowheads="1"/>
          </p:cNvSpPr>
          <p:nvPr/>
        </p:nvSpPr>
        <p:spPr bwMode="auto">
          <a:xfrm>
            <a:off x="1157292" y="2593045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 Box 26"/>
          <p:cNvSpPr txBox="1">
            <a:spLocks noChangeArrowheads="1"/>
          </p:cNvSpPr>
          <p:nvPr/>
        </p:nvSpPr>
        <p:spPr bwMode="auto">
          <a:xfrm>
            <a:off x="1235262" y="4787025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 Box 26"/>
          <p:cNvSpPr txBox="1">
            <a:spLocks noChangeArrowheads="1"/>
          </p:cNvSpPr>
          <p:nvPr/>
        </p:nvSpPr>
        <p:spPr bwMode="auto">
          <a:xfrm>
            <a:off x="-253562" y="-152772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374105" y="9481293"/>
            <a:ext cx="23791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Additional File 4: Figure S1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Char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4004001"/>
              </p:ext>
            </p:extLst>
          </p:nvPr>
        </p:nvGraphicFramePr>
        <p:xfrm>
          <a:off x="526849" y="737451"/>
          <a:ext cx="260092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278621"/>
              </p:ext>
            </p:extLst>
          </p:nvPr>
        </p:nvGraphicFramePr>
        <p:xfrm>
          <a:off x="3706844" y="739042"/>
          <a:ext cx="260247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Char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4216981"/>
              </p:ext>
            </p:extLst>
          </p:nvPr>
        </p:nvGraphicFramePr>
        <p:xfrm>
          <a:off x="523802" y="2944452"/>
          <a:ext cx="260092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8" name="Char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870991"/>
              </p:ext>
            </p:extLst>
          </p:nvPr>
        </p:nvGraphicFramePr>
        <p:xfrm>
          <a:off x="3706844" y="2942211"/>
          <a:ext cx="260247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9" name="Char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7941936"/>
              </p:ext>
            </p:extLst>
          </p:nvPr>
        </p:nvGraphicFramePr>
        <p:xfrm>
          <a:off x="520105" y="5125482"/>
          <a:ext cx="260092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0" name="Char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6568154"/>
              </p:ext>
            </p:extLst>
          </p:nvPr>
        </p:nvGraphicFramePr>
        <p:xfrm>
          <a:off x="3706844" y="5126800"/>
          <a:ext cx="260247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1" name="Char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5721919"/>
              </p:ext>
            </p:extLst>
          </p:nvPr>
        </p:nvGraphicFramePr>
        <p:xfrm>
          <a:off x="520177" y="7295892"/>
          <a:ext cx="260092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2" name="Char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6150587"/>
              </p:ext>
            </p:extLst>
          </p:nvPr>
        </p:nvGraphicFramePr>
        <p:xfrm>
          <a:off x="3706844" y="7293260"/>
          <a:ext cx="2602476" cy="156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" name="TextBox 1"/>
          <p:cNvSpPr txBox="1"/>
          <p:nvPr/>
        </p:nvSpPr>
        <p:spPr>
          <a:xfrm rot="-2400000">
            <a:off x="930030" y="221815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-2400000">
            <a:off x="750418" y="2348950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-2400000">
            <a:off x="947829" y="2355326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36" name="TextBox 35"/>
          <p:cNvSpPr txBox="1"/>
          <p:nvPr/>
        </p:nvSpPr>
        <p:spPr>
          <a:xfrm rot="-2400000">
            <a:off x="1190987" y="2318802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-2400000">
            <a:off x="1433422" y="2318802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-2400000">
            <a:off x="1681978" y="2296518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-2400000">
            <a:off x="1944915" y="2275910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-2400000">
            <a:off x="2439601" y="221704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-2400000">
            <a:off x="2592101" y="224667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-2400000">
            <a:off x="2183930" y="2249071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-2400000">
            <a:off x="940124" y="4409537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-2400000">
            <a:off x="760512" y="4540328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-2400000">
            <a:off x="957923" y="4546704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46" name="TextBox 45"/>
          <p:cNvSpPr txBox="1"/>
          <p:nvPr/>
        </p:nvSpPr>
        <p:spPr>
          <a:xfrm rot="-2400000">
            <a:off x="1201081" y="4510180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-2400000">
            <a:off x="1443516" y="4510180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-2400000">
            <a:off x="1692072" y="448789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-2400000">
            <a:off x="1955009" y="446728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-2400000">
            <a:off x="2449695" y="440842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-2400000">
            <a:off x="2602195" y="443805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-2400000">
            <a:off x="2194024" y="444044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 Box 26"/>
          <p:cNvSpPr txBox="1">
            <a:spLocks noChangeArrowheads="1"/>
          </p:cNvSpPr>
          <p:nvPr/>
        </p:nvSpPr>
        <p:spPr bwMode="auto">
          <a:xfrm>
            <a:off x="1235571" y="6952723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 rot="-2400000">
            <a:off x="940433" y="657523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-2400000">
            <a:off x="760821" y="6706026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-2400000">
            <a:off x="958232" y="6712402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78" name="TextBox 77"/>
          <p:cNvSpPr txBox="1"/>
          <p:nvPr/>
        </p:nvSpPr>
        <p:spPr>
          <a:xfrm rot="-2400000">
            <a:off x="1201390" y="667587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-2400000">
            <a:off x="1443825" y="6675878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-2400000">
            <a:off x="1692381" y="665359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 rot="-2400000">
            <a:off x="1955318" y="66329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-2400000">
            <a:off x="2450004" y="657412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-2400000">
            <a:off x="2602504" y="660375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-2400000">
            <a:off x="2194333" y="660614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 Box 26"/>
          <p:cNvSpPr txBox="1">
            <a:spLocks noChangeArrowheads="1"/>
          </p:cNvSpPr>
          <p:nvPr/>
        </p:nvSpPr>
        <p:spPr bwMode="auto">
          <a:xfrm>
            <a:off x="1235262" y="9123133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 rot="-2400000">
            <a:off x="940124" y="874564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 rot="-2400000">
            <a:off x="760512" y="8876436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-2400000">
            <a:off x="957923" y="8882812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89" name="TextBox 88"/>
          <p:cNvSpPr txBox="1"/>
          <p:nvPr/>
        </p:nvSpPr>
        <p:spPr>
          <a:xfrm rot="-2400000">
            <a:off x="1201081" y="884628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-2400000">
            <a:off x="1443516" y="8846288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 rot="-2400000">
            <a:off x="1692072" y="882400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-2400000">
            <a:off x="1955009" y="880339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-2400000">
            <a:off x="2449695" y="874453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-2400000">
            <a:off x="2602195" y="877416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-2400000">
            <a:off x="2194024" y="877655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 Box 51"/>
          <p:cNvSpPr txBox="1">
            <a:spLocks noChangeArrowheads="1"/>
          </p:cNvSpPr>
          <p:nvPr/>
        </p:nvSpPr>
        <p:spPr bwMode="auto">
          <a:xfrm rot="16200000">
            <a:off x="-201645" y="7908515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 Box 26"/>
          <p:cNvSpPr txBox="1">
            <a:spLocks noChangeArrowheads="1"/>
          </p:cNvSpPr>
          <p:nvPr/>
        </p:nvSpPr>
        <p:spPr bwMode="auto">
          <a:xfrm>
            <a:off x="4344000" y="2632243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 rot="-2400000">
            <a:off x="4116738" y="2212352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 rot="-2400000">
            <a:off x="3937126" y="2343143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 rot="-2400000">
            <a:off x="4134537" y="2349519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101" name="TextBox 100"/>
          <p:cNvSpPr txBox="1"/>
          <p:nvPr/>
        </p:nvSpPr>
        <p:spPr>
          <a:xfrm rot="-2400000">
            <a:off x="4377695" y="2312995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 rot="-2400000">
            <a:off x="4620130" y="2312995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 rot="-2400000">
            <a:off x="4868686" y="229071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 rot="-2400000">
            <a:off x="5131623" y="2270103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 rot="-2400000">
            <a:off x="5626309" y="221123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 rot="-2400000">
            <a:off x="5778809" y="224086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 rot="-2400000">
            <a:off x="5370638" y="2243264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 Box 51"/>
          <p:cNvSpPr txBox="1">
            <a:spLocks noChangeArrowheads="1"/>
          </p:cNvSpPr>
          <p:nvPr/>
        </p:nvSpPr>
        <p:spPr bwMode="auto">
          <a:xfrm rot="16200000">
            <a:off x="2960887" y="3527872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 Box 26"/>
          <p:cNvSpPr txBox="1">
            <a:spLocks noChangeArrowheads="1"/>
          </p:cNvSpPr>
          <p:nvPr/>
        </p:nvSpPr>
        <p:spPr bwMode="auto">
          <a:xfrm>
            <a:off x="4411876" y="4789645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 rot="-2400000">
            <a:off x="4116738" y="4412157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 rot="-2400000">
            <a:off x="3937126" y="4542948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 rot="-2400000">
            <a:off x="4134537" y="4549324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113" name="TextBox 112"/>
          <p:cNvSpPr txBox="1"/>
          <p:nvPr/>
        </p:nvSpPr>
        <p:spPr>
          <a:xfrm rot="-2400000">
            <a:off x="4377695" y="4512800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 rot="-2400000">
            <a:off x="4620130" y="4512800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 rot="-2400000">
            <a:off x="4868686" y="449051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 rot="-2400000">
            <a:off x="5131623" y="4469908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 rot="-2400000">
            <a:off x="5626309" y="441104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 rot="-2400000">
            <a:off x="5778809" y="444067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 rot="-2400000">
            <a:off x="5370638" y="444306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 Box 26"/>
          <p:cNvSpPr txBox="1">
            <a:spLocks noChangeArrowheads="1"/>
          </p:cNvSpPr>
          <p:nvPr/>
        </p:nvSpPr>
        <p:spPr bwMode="auto">
          <a:xfrm>
            <a:off x="4411876" y="6952723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 rot="-2400000">
            <a:off x="4116738" y="657523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 rot="-2400000">
            <a:off x="3937126" y="6706026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 rot="-2400000">
            <a:off x="4134537" y="6712402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124" name="TextBox 123"/>
          <p:cNvSpPr txBox="1"/>
          <p:nvPr/>
        </p:nvSpPr>
        <p:spPr>
          <a:xfrm rot="-2400000">
            <a:off x="4377695" y="667587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 rot="-2400000">
            <a:off x="4620130" y="6675878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 rot="-2400000">
            <a:off x="4868686" y="665359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 rot="-2400000">
            <a:off x="5131623" y="663298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 rot="-2400000">
            <a:off x="5626309" y="657412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 rot="-2400000">
            <a:off x="5778809" y="660375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 rot="-2400000">
            <a:off x="5370638" y="6606147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 Box 26"/>
          <p:cNvSpPr txBox="1">
            <a:spLocks noChangeArrowheads="1"/>
          </p:cNvSpPr>
          <p:nvPr/>
        </p:nvSpPr>
        <p:spPr bwMode="auto">
          <a:xfrm>
            <a:off x="4411876" y="913265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 (</a:t>
            </a:r>
            <a:r>
              <a:rPr lang="en-US" altLang="it-IT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 rot="-2400000">
            <a:off x="4116738" y="8755170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 rot="-2400000">
            <a:off x="3937126" y="8885961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39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 rot="-2400000">
            <a:off x="4134537" y="8892337"/>
            <a:ext cx="6655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078125</a:t>
            </a:r>
          </a:p>
        </p:txBody>
      </p:sp>
      <p:sp>
        <p:nvSpPr>
          <p:cNvPr id="135" name="TextBox 134"/>
          <p:cNvSpPr txBox="1"/>
          <p:nvPr/>
        </p:nvSpPr>
        <p:spPr>
          <a:xfrm rot="-2400000">
            <a:off x="4377695" y="8855813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5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 rot="-2400000">
            <a:off x="4620130" y="8855813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31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 rot="-2400000">
            <a:off x="4868686" y="883352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6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 rot="-2400000">
            <a:off x="5131623" y="88129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 rot="-2400000">
            <a:off x="5626309" y="875405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rot="-2400000">
            <a:off x="5778809" y="878368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 rot="-2400000">
            <a:off x="5370638" y="8786082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 Box 26"/>
          <p:cNvSpPr txBox="1">
            <a:spLocks noChangeArrowheads="1"/>
          </p:cNvSpPr>
          <p:nvPr/>
        </p:nvSpPr>
        <p:spPr bwMode="auto">
          <a:xfrm>
            <a:off x="1110179" y="66154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 Box 26"/>
          <p:cNvSpPr txBox="1">
            <a:spLocks noChangeArrowheads="1"/>
          </p:cNvSpPr>
          <p:nvPr/>
        </p:nvSpPr>
        <p:spPr bwMode="auto">
          <a:xfrm>
            <a:off x="4196624" y="66154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 Box 26"/>
          <p:cNvSpPr txBox="1">
            <a:spLocks noChangeArrowheads="1"/>
          </p:cNvSpPr>
          <p:nvPr/>
        </p:nvSpPr>
        <p:spPr bwMode="auto">
          <a:xfrm>
            <a:off x="1133745" y="2866793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46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 Box 26"/>
          <p:cNvSpPr txBox="1">
            <a:spLocks noChangeArrowheads="1"/>
          </p:cNvSpPr>
          <p:nvPr/>
        </p:nvSpPr>
        <p:spPr bwMode="auto">
          <a:xfrm>
            <a:off x="4220190" y="2866793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46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 Box 51"/>
          <p:cNvSpPr txBox="1">
            <a:spLocks noChangeArrowheads="1"/>
          </p:cNvSpPr>
          <p:nvPr/>
        </p:nvSpPr>
        <p:spPr bwMode="auto">
          <a:xfrm rot="16200000">
            <a:off x="2960887" y="5733117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 Box 51"/>
          <p:cNvSpPr txBox="1">
            <a:spLocks noChangeArrowheads="1"/>
          </p:cNvSpPr>
          <p:nvPr/>
        </p:nvSpPr>
        <p:spPr bwMode="auto">
          <a:xfrm rot="16200000">
            <a:off x="2960887" y="7903527"/>
            <a:ext cx="12298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cell numbe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/untreated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 Box 26"/>
          <p:cNvSpPr txBox="1">
            <a:spLocks noChangeArrowheads="1"/>
          </p:cNvSpPr>
          <p:nvPr/>
        </p:nvSpPr>
        <p:spPr bwMode="auto">
          <a:xfrm>
            <a:off x="1133745" y="507203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322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 Box 26"/>
          <p:cNvSpPr txBox="1">
            <a:spLocks noChangeArrowheads="1"/>
          </p:cNvSpPr>
          <p:nvPr/>
        </p:nvSpPr>
        <p:spPr bwMode="auto">
          <a:xfrm>
            <a:off x="4220190" y="507203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322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 Box 26"/>
          <p:cNvSpPr txBox="1">
            <a:spLocks noChangeArrowheads="1"/>
          </p:cNvSpPr>
          <p:nvPr/>
        </p:nvSpPr>
        <p:spPr bwMode="auto">
          <a:xfrm>
            <a:off x="1133745" y="723227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 Box 26"/>
          <p:cNvSpPr txBox="1">
            <a:spLocks noChangeArrowheads="1"/>
          </p:cNvSpPr>
          <p:nvPr/>
        </p:nvSpPr>
        <p:spPr bwMode="auto">
          <a:xfrm>
            <a:off x="4220190" y="7232278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54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884944" y="497505"/>
            <a:ext cx="21031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>
            <a:off x="4035294" y="497505"/>
            <a:ext cx="21031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 Box 26"/>
          <p:cNvSpPr txBox="1">
            <a:spLocks noChangeArrowheads="1"/>
          </p:cNvSpPr>
          <p:nvPr/>
        </p:nvSpPr>
        <p:spPr bwMode="auto">
          <a:xfrm>
            <a:off x="1108719" y="257490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 Box 26"/>
          <p:cNvSpPr txBox="1">
            <a:spLocks noChangeArrowheads="1"/>
          </p:cNvSpPr>
          <p:nvPr/>
        </p:nvSpPr>
        <p:spPr bwMode="auto">
          <a:xfrm>
            <a:off x="4194085" y="257490"/>
            <a:ext cx="160020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JNJ-BJ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6252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80" y="317485"/>
            <a:ext cx="585065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4: Figure S1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NKS inhibition does not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bstantially affect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</a:p>
          <a:p>
            <a:pPr algn="just"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rowth curves of H322, HCC827, A549, and H460 cells treat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r 72h with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creasing concentrations of either XAV939 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JNJ-BJ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s described in Materials and Methods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mpounds were refreshed after 48h. Valu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re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verage (lines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ang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wo independent experiments (diamonds), each perform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chnical quadruplicate. Raw data are shown in Additional Fil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KSi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TNKS inhibitor.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374105" y="9481293"/>
            <a:ext cx="23791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Additional File 4: Figure S1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4796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690</TotalTime>
  <Words>288</Words>
  <Application>Microsoft Office PowerPoint</Application>
  <PresentationFormat>A4 Paper (210x297 mm)</PresentationFormat>
  <Paragraphs>120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39</cp:revision>
  <cp:lastPrinted>2014-11-21T15:42:42Z</cp:lastPrinted>
  <dcterms:created xsi:type="dcterms:W3CDTF">2006-08-16T00:00:00Z</dcterms:created>
  <dcterms:modified xsi:type="dcterms:W3CDTF">2015-12-14T09:36:47Z</dcterms:modified>
</cp:coreProperties>
</file>